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314" r:id="rId2"/>
    <p:sldId id="315" r:id="rId3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21" userDrawn="1">
          <p15:clr>
            <a:srgbClr val="A4A3A4"/>
          </p15:clr>
        </p15:guide>
        <p15:guide id="2" pos="164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1DFDCD1-EF6B-3F80-07E7-35A56DD59C0E}" name="Charleen Chan" initials="CC" userId="S::charleen.chan@icr.ac.uk::73a26ce7-f665-4248-b705-b0b5a6e7a5b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050"/>
    <a:srgbClr val="FF6699"/>
    <a:srgbClr val="CC0000"/>
    <a:srgbClr val="CC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04"/>
    <p:restoredTop sz="92017"/>
  </p:normalViewPr>
  <p:slideViewPr>
    <p:cSldViewPr snapToGrid="0">
      <p:cViewPr>
        <p:scale>
          <a:sx n="208" d="100"/>
          <a:sy n="208" d="100"/>
        </p:scale>
        <p:origin x="584" y="144"/>
      </p:cViewPr>
      <p:guideLst>
        <p:guide orient="horz" pos="2621"/>
        <p:guide pos="1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224BE0-296C-2D4A-8E47-23328EA7FFFE}" type="datetimeFigureOut">
              <a:rPr lang="en-US" smtClean="0"/>
              <a:t>10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9F04B6-F912-E44D-B4F8-91F0A27773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9782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1936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8560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9420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4869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786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2442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4570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7527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6618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9911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507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6B1A1B-3D8C-460A-ABB6-2B36767CC72E}" type="datetimeFigureOut">
              <a:rPr lang="en-GB" smtClean="0"/>
              <a:t>09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D68795-689F-4A24-9C3D-ABF4B71A19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6519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0738F8CA-FB4A-493B-00D3-95C3D9F9ECCD}"/>
              </a:ext>
            </a:extLst>
          </p:cNvPr>
          <p:cNvSpPr txBox="1"/>
          <p:nvPr/>
        </p:nvSpPr>
        <p:spPr>
          <a:xfrm>
            <a:off x="-4225" y="278191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DA25F96-52FF-432E-9B03-9956E8B2C16F}"/>
              </a:ext>
            </a:extLst>
          </p:cNvPr>
          <p:cNvSpPr txBox="1"/>
          <p:nvPr/>
        </p:nvSpPr>
        <p:spPr>
          <a:xfrm>
            <a:off x="400044" y="122108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EER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D77F5D8-2E7F-D9B4-1B11-B37D1210DD45}"/>
              </a:ext>
            </a:extLst>
          </p:cNvPr>
          <p:cNvSpPr txBox="1"/>
          <p:nvPr/>
        </p:nvSpPr>
        <p:spPr>
          <a:xfrm>
            <a:off x="5393" y="103948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E463EC5-2227-8DE5-2C44-EBE28EFFEB35}"/>
              </a:ext>
            </a:extLst>
          </p:cNvPr>
          <p:cNvSpPr txBox="1"/>
          <p:nvPr/>
        </p:nvSpPr>
        <p:spPr>
          <a:xfrm>
            <a:off x="-1864" y="469672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2448BD1-7078-53C9-63B7-BCB5A5FFA071}"/>
              </a:ext>
            </a:extLst>
          </p:cNvPr>
          <p:cNvSpPr txBox="1"/>
          <p:nvPr/>
        </p:nvSpPr>
        <p:spPr>
          <a:xfrm>
            <a:off x="3049810" y="277592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68EDB7A-9D6F-6DB3-F15F-3B988FBDBF4B}"/>
              </a:ext>
            </a:extLst>
          </p:cNvPr>
          <p:cNvSpPr txBox="1"/>
          <p:nvPr/>
        </p:nvSpPr>
        <p:spPr>
          <a:xfrm>
            <a:off x="5883966" y="67753"/>
            <a:ext cx="12333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94BDCE2-A23A-616A-B322-1D9F402FC2D0}"/>
              </a:ext>
            </a:extLst>
          </p:cNvPr>
          <p:cNvSpPr txBox="1"/>
          <p:nvPr/>
        </p:nvSpPr>
        <p:spPr>
          <a:xfrm>
            <a:off x="3429000" y="469672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C6330C50-A7AB-25C9-7A70-40E68520EEF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5623" t="72993" r="19927"/>
          <a:stretch>
            <a:fillRect/>
          </a:stretch>
        </p:blipFill>
        <p:spPr>
          <a:xfrm>
            <a:off x="2256022" y="3828737"/>
            <a:ext cx="1071798" cy="644264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9427B485-FF19-B714-4322-3D70F64199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025854"/>
            <a:ext cx="2665656" cy="1679461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81D8B84A-7BB1-AAAD-627F-6F9C5B7F7AB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2308" y="269823"/>
            <a:ext cx="5999358" cy="2551197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C64B5457-EA98-7C2F-2DDC-FA4C9F0C0B1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35310" y="3087414"/>
            <a:ext cx="3522689" cy="1383141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C75A0D98-ED6E-A566-49BC-FCB5057EC25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65062" y="4978401"/>
            <a:ext cx="3392938" cy="1527946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71C6A620-4BE0-0D3F-B32D-2F1E502E2E6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66380" y="6604832"/>
            <a:ext cx="1614454" cy="1317823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A789AA81-BC81-6BA5-0E72-44E2D1CB2ED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10263" y="8058879"/>
            <a:ext cx="3326268" cy="1496528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694BAA52-69CC-9C06-8CD2-B58E3CC720B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9942" y="4945783"/>
            <a:ext cx="3125449" cy="26095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02553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8DBED10-4B99-4104-BF7F-4927C87EF2CD}"/>
              </a:ext>
            </a:extLst>
          </p:cNvPr>
          <p:cNvSpPr txBox="1"/>
          <p:nvPr/>
        </p:nvSpPr>
        <p:spPr>
          <a:xfrm>
            <a:off x="413951" y="278027"/>
            <a:ext cx="601774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In vivo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tudies of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xevinapant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in combination with RT or CRT in the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EER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model. A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Individual tumour growth curves across different treatment conditions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verage tumour growth curves across different treatment conditions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Kaplan–Meier survival curves across different treatment conditions (11-12 mice/group)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Individual tumour growth curves of 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in vivo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anti-CD8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(⍺CD8) depletion (11-15 mice/group)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E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Pilot experiment of the addition of anti-PD-1 (⍺PD-1) to CRT plus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xevinapant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(6 mice/group): average tumour growth curves, individual tumour growth curves and Kaplan–Meier survival curves. All data representative of ≥2 independent experiments except for in E (performed once). </a:t>
            </a:r>
          </a:p>
        </p:txBody>
      </p:sp>
    </p:spTree>
    <p:extLst>
      <p:ext uri="{BB962C8B-B14F-4D97-AF65-F5344CB8AC3E}">
        <p14:creationId xmlns:p14="http://schemas.microsoft.com/office/powerpoint/2010/main" val="29445845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34</TotalTime>
  <Words>142</Words>
  <Application>Microsoft Macintosh PowerPoint</Application>
  <PresentationFormat>A4 Paper (210x297 mm)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Institute of Cancer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nuel Patin</dc:creator>
  <cp:lastModifiedBy>Charleen Chan</cp:lastModifiedBy>
  <cp:revision>535</cp:revision>
  <cp:lastPrinted>2025-06-25T15:47:08Z</cp:lastPrinted>
  <dcterms:created xsi:type="dcterms:W3CDTF">2019-11-04T10:33:30Z</dcterms:created>
  <dcterms:modified xsi:type="dcterms:W3CDTF">2025-10-09T08:52:52Z</dcterms:modified>
</cp:coreProperties>
</file>